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D2285E-0EAA-4EC0-BF8A-8DB07CB3A29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9220E0-8C43-4B88-8F51-CC4D2A4D58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3C66F-39D7-47FC-ADEC-35FEE90A78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CE227B-3346-4C0E-8410-CCCC094ADF0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FF532-24CD-4358-BCCA-A653B1DCAB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FB6D4-6EA2-4D2D-B075-B3A5F295E0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51D4D2-17E3-4692-9281-977CF7BD8D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C7A7C-9E99-4016-AECF-B2E8929EC6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C364E1-5653-494C-ADFD-DAAAFA620F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E24639-B1AD-43FE-AA10-FEBEE327B5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BDFCD0-1BE1-473A-972A-F0D12B75B0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B318C1-4BA4-47E4-9179-776E76E22A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BE1168-23E4-4658-B636-6FB7BCB0B10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0" r="0" b="4779"/>
          <a:stretch/>
        </p:blipFill>
        <p:spPr>
          <a:xfrm>
            <a:off x="0" y="1008000"/>
            <a:ext cx="9144000" cy="281304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5217" r="0" b="0"/>
          <a:stretch/>
        </p:blipFill>
        <p:spPr>
          <a:xfrm>
            <a:off x="442800" y="4000680"/>
            <a:ext cx="3764160" cy="283032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4646520" y="4065480"/>
            <a:ext cx="4021200" cy="255456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-23760" y="65880"/>
            <a:ext cx="91677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data 5. (A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Morphology of SS mitochondria in gastrocnrmius muscle of N, HFD, and HFD+T2 rats at high magnification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Morphometric analysis of SS mitochondria in gastrocnemius muscle of N, HFD, and HFD+T2 rats. Frequency distributions were determined for surface area (nm2). In the table, the value of the range of areas for the three experimental groups is report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8"/>
          <p:cNvSpPr/>
          <p:nvPr/>
        </p:nvSpPr>
        <p:spPr>
          <a:xfrm>
            <a:off x="-81000" y="944640"/>
            <a:ext cx="638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59"/>
          <p:cNvSpPr/>
          <p:nvPr/>
        </p:nvSpPr>
        <p:spPr>
          <a:xfrm>
            <a:off x="-81000" y="3817800"/>
            <a:ext cx="638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SBA</cp:lastModifiedBy>
  <dcterms:modified xsi:type="dcterms:W3CDTF">2018-01-26T15:15:40Z</dcterms:modified>
  <cp:revision>7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